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40" r:id="rId2"/>
    <p:sldId id="343" r:id="rId3"/>
    <p:sldId id="345" r:id="rId4"/>
    <p:sldId id="347" r:id="rId5"/>
    <p:sldId id="348" r:id="rId6"/>
    <p:sldId id="349" r:id="rId7"/>
    <p:sldId id="350" r:id="rId8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378" y="102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1B3203-7223-4ECA-9B64-A5A2E5C6994F}" type="datetimeFigureOut">
              <a:rPr lang="en-IL" smtClean="0"/>
              <a:t>09/18/2022</a:t>
            </a:fld>
            <a:endParaRPr lang="en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65F53E-B385-4DB3-A9E4-664150DA0AD3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1438660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65F53E-B385-4DB3-A9E4-664150DA0AD3}" type="slidenum">
              <a:rPr lang="en-IL" smtClean="0"/>
              <a:t>4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5392580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C307A-743A-47F6-B44E-875A90670242}" type="datetimeFigureOut">
              <a:rPr lang="en-US" smtClean="0"/>
              <a:pPr/>
              <a:t>9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6C82B-0D52-41EC-85CE-8BBC0B2FA5F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0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</a:p>
        </p:txBody>
      </p:sp>
      <p:sp>
        <p:nvSpPr>
          <p:cNvPr id="8" name="TextBox 29">
            <a:extLst>
              <a:ext uri="{FF2B5EF4-FFF2-40B4-BE49-F238E27FC236}">
                <a16:creationId xmlns:a16="http://schemas.microsoft.com/office/drawing/2014/main" id="{6416E66E-6A7B-433B-B33E-E0ADDF52D050}"/>
              </a:ext>
            </a:extLst>
          </p:cNvPr>
          <p:cNvSpPr txBox="1"/>
          <p:nvPr/>
        </p:nvSpPr>
        <p:spPr>
          <a:xfrm>
            <a:off x="3613737" y="3581401"/>
            <a:ext cx="2497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spH</a:t>
            </a:r>
            <a:r>
              <a:rPr lang="en-US" sz="1200" b="1" baseline="-25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US" sz="1200" b="1" i="1" baseline="-25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0-168</a:t>
            </a:r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inders (Table S1B)</a:t>
            </a:r>
          </a:p>
        </p:txBody>
      </p:sp>
      <p:sp>
        <p:nvSpPr>
          <p:cNvPr id="9" name="TextBox 30">
            <a:extLst>
              <a:ext uri="{FF2B5EF4-FFF2-40B4-BE49-F238E27FC236}">
                <a16:creationId xmlns:a16="http://schemas.microsoft.com/office/drawing/2014/main" id="{45C6FBB3-EE7D-4EB4-9329-411CDA2F929C}"/>
              </a:ext>
            </a:extLst>
          </p:cNvPr>
          <p:cNvSpPr txBox="1"/>
          <p:nvPr/>
        </p:nvSpPr>
        <p:spPr>
          <a:xfrm>
            <a:off x="3830161" y="1070550"/>
            <a:ext cx="2213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b="1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spH</a:t>
            </a:r>
            <a:r>
              <a:rPr lang="en-US" sz="1200" b="1" i="1" baseline="-2500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inders (Table S1A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3AAC20D-7FC3-4FA4-870E-EB58FE30E420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695700" y="1513609"/>
            <a:ext cx="2362200" cy="17317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497DEFC-6D13-4C96-B98A-23243F33474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3800" y="4038600"/>
            <a:ext cx="2438400" cy="1773382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B0C275B-0BD8-4D5A-90C1-7A417EBADE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447307"/>
            <a:ext cx="4914900" cy="12287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80F0294-F4BC-44D8-8234-5647D6B8BE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850" y="2372369"/>
            <a:ext cx="3307986" cy="234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A1F74FD-390A-4032-9012-166179642E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57213" y="2372369"/>
            <a:ext cx="2772610" cy="234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6BB3D66-419D-4169-8CF5-F95D69F055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34200" y="2259000"/>
            <a:ext cx="2736283" cy="2340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C6E7C80-8C09-4FFD-A907-911474DFAC25}"/>
              </a:ext>
            </a:extLst>
          </p:cNvPr>
          <p:cNvSpPr txBox="1"/>
          <p:nvPr/>
        </p:nvSpPr>
        <p:spPr>
          <a:xfrm>
            <a:off x="1942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5891117-D248-4466-8162-3FB3AA167186}"/>
              </a:ext>
            </a:extLst>
          </p:cNvPr>
          <p:cNvSpPr txBox="1"/>
          <p:nvPr/>
        </p:nvSpPr>
        <p:spPr>
          <a:xfrm>
            <a:off x="469161" y="18601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0F38BF3-D356-439A-ADD8-A19C042BEB97}"/>
              </a:ext>
            </a:extLst>
          </p:cNvPr>
          <p:cNvSpPr txBox="1"/>
          <p:nvPr/>
        </p:nvSpPr>
        <p:spPr>
          <a:xfrm>
            <a:off x="3733800" y="1785034"/>
            <a:ext cx="445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846475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361A21A-0684-4928-A037-0D940F3043A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46" t="23578" r="887" b="3028"/>
          <a:stretch/>
        </p:blipFill>
        <p:spPr>
          <a:xfrm>
            <a:off x="1134600" y="1269000"/>
            <a:ext cx="3369600" cy="2160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420D09A-13FD-4154-A9EC-4866A061A6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4600" y="160016"/>
            <a:ext cx="5295900" cy="5905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5FD285B-2512-4F2D-BA1F-5E2467122E70}"/>
              </a:ext>
            </a:extLst>
          </p:cNvPr>
          <p:cNvSpPr txBox="1"/>
          <p:nvPr/>
        </p:nvSpPr>
        <p:spPr>
          <a:xfrm>
            <a:off x="0" y="1436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F742B9B-8AE6-4305-B3E9-D4B1BA455E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24000" y="3581400"/>
            <a:ext cx="2330531" cy="2160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B4B2B75-7DDB-4D75-9E50-D1F5FF4C62B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46" t="20909" r="21"/>
          <a:stretch/>
        </p:blipFill>
        <p:spPr>
          <a:xfrm>
            <a:off x="5401802" y="1269000"/>
            <a:ext cx="3125793" cy="216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AAF9181-8F66-4B2C-9456-0FCC055FFAE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2747"/>
          <a:stretch/>
        </p:blipFill>
        <p:spPr>
          <a:xfrm>
            <a:off x="5467352" y="3581400"/>
            <a:ext cx="2768105" cy="216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3C8AC71-59CC-4BCA-9DCE-1062B3F50AF7}"/>
              </a:ext>
            </a:extLst>
          </p:cNvPr>
          <p:cNvSpPr txBox="1"/>
          <p:nvPr/>
        </p:nvSpPr>
        <p:spPr>
          <a:xfrm>
            <a:off x="513812" y="899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4AB209-E27A-4784-9B1C-33D8848AE3FE}"/>
              </a:ext>
            </a:extLst>
          </p:cNvPr>
          <p:cNvSpPr txBox="1"/>
          <p:nvPr/>
        </p:nvSpPr>
        <p:spPr>
          <a:xfrm>
            <a:off x="4953000" y="899668"/>
            <a:ext cx="445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765114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9108DA0-C71F-4DF6-A80E-CC1B097F8D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1400" y="381000"/>
            <a:ext cx="3228975" cy="4095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8847F79-0FD3-4937-BF99-AED6E41EAAD9}"/>
              </a:ext>
            </a:extLst>
          </p:cNvPr>
          <p:cNvSpPr txBox="1"/>
          <p:nvPr/>
        </p:nvSpPr>
        <p:spPr>
          <a:xfrm>
            <a:off x="851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7F5F606-5A5F-4344-AC75-D75E08C30D1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06" t="29630" r="1789"/>
          <a:stretch/>
        </p:blipFill>
        <p:spPr>
          <a:xfrm>
            <a:off x="648002" y="1447800"/>
            <a:ext cx="4160844" cy="162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A55D63C-FD3D-4A51-A6FA-C674CD384F7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10" t="30419" r="840"/>
          <a:stretch/>
        </p:blipFill>
        <p:spPr>
          <a:xfrm>
            <a:off x="5382543" y="1447800"/>
            <a:ext cx="3907539" cy="1620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A915494-67FC-4D8A-9602-8BAB485ABA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19383" y="3429000"/>
            <a:ext cx="3027909" cy="270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E6A96D8-46D5-4F2A-93F0-05FE336C87E0}"/>
              </a:ext>
            </a:extLst>
          </p:cNvPr>
          <p:cNvSpPr txBox="1"/>
          <p:nvPr/>
        </p:nvSpPr>
        <p:spPr>
          <a:xfrm>
            <a:off x="513812" y="899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76393A6-7BBF-40D5-8CA7-64026D06D0A0}"/>
              </a:ext>
            </a:extLst>
          </p:cNvPr>
          <p:cNvSpPr txBox="1"/>
          <p:nvPr/>
        </p:nvSpPr>
        <p:spPr>
          <a:xfrm>
            <a:off x="4953000" y="899668"/>
            <a:ext cx="445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408376-471F-46EF-BF85-F04CD3EEE9F1}"/>
              </a:ext>
            </a:extLst>
          </p:cNvPr>
          <p:cNvSpPr txBox="1"/>
          <p:nvPr/>
        </p:nvSpPr>
        <p:spPr>
          <a:xfrm>
            <a:off x="3072271" y="3420869"/>
            <a:ext cx="4452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ED5BF02-D100-4061-AA6E-060D856599A7}"/>
              </a:ext>
            </a:extLst>
          </p:cNvPr>
          <p:cNvSpPr/>
          <p:nvPr/>
        </p:nvSpPr>
        <p:spPr>
          <a:xfrm>
            <a:off x="5715000" y="4838700"/>
            <a:ext cx="381000" cy="228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0590961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B110076-E4FE-D7FE-D8AB-B93FF71A58C1}"/>
              </a:ext>
            </a:extLst>
          </p:cNvPr>
          <p:cNvSpPr txBox="1"/>
          <p:nvPr/>
        </p:nvSpPr>
        <p:spPr>
          <a:xfrm>
            <a:off x="1942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07AA4E6-F85A-9E95-4F15-4D70D94C59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6960" y="1507236"/>
            <a:ext cx="5212080" cy="3843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75715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2C322716-4015-4E2C-A1A0-DEBA7FA1F3FB}"/>
              </a:ext>
            </a:extLst>
          </p:cNvPr>
          <p:cNvSpPr txBox="1"/>
          <p:nvPr/>
        </p:nvSpPr>
        <p:spPr>
          <a:xfrm>
            <a:off x="0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04F9356-80A8-332D-7A8B-021D52E5EF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5752" y="215900"/>
            <a:ext cx="3694496" cy="313361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05C5822-7BAA-6ACD-8635-B9DE9D9C5C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6600" y="3316565"/>
            <a:ext cx="2692908" cy="3182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78035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7B1B36A-3355-4887-863C-FE6C13B9B418}"/>
              </a:ext>
            </a:extLst>
          </p:cNvPr>
          <p:cNvSpPr txBox="1"/>
          <p:nvPr/>
        </p:nvSpPr>
        <p:spPr>
          <a:xfrm>
            <a:off x="0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1CAFA35-93A6-9E3F-31A8-C3E8B21BA8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6600" y="1371600"/>
            <a:ext cx="3154680" cy="3997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3588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96</TotalTime>
  <Words>43</Words>
  <Application>Microsoft Office PowerPoint</Application>
  <PresentationFormat>A4 Paper (210x297 mm)</PresentationFormat>
  <Paragraphs>17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enjamin Aroeti</dc:creator>
  <cp:lastModifiedBy>ipsita nandi</cp:lastModifiedBy>
  <cp:revision>146</cp:revision>
  <dcterms:created xsi:type="dcterms:W3CDTF">2020-06-01T13:31:04Z</dcterms:created>
  <dcterms:modified xsi:type="dcterms:W3CDTF">2022-09-18T11:06:24Z</dcterms:modified>
</cp:coreProperties>
</file>